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6" d="100"/>
          <a:sy n="96" d="100"/>
        </p:scale>
        <p:origin x="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C628DB-F59F-4BD8-B99B-F0A995797E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7DCE7EA-D686-4CDF-841E-CB5163BB7A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14E9427-03C5-4C50-885C-50D5652C8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B9E44-29F0-40E7-8285-89257AB41C9A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0C0252-D908-4D7B-A7D9-BAE545BB6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F4D03BF-D436-45ED-9B03-249A8ACF1B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66F8-1689-45AC-97FE-131929E0C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2938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856655-EA41-4FA9-88B8-C247C62487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E055622-8F26-4EB0-AC37-9E5C4BFF48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577026-4BBC-4817-96BA-A30768F78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B9E44-29F0-40E7-8285-89257AB41C9A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BBF7EC8-E22B-45A2-8416-BF78C84B86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E05F71-5B3A-4D1E-9E57-7810E539B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66F8-1689-45AC-97FE-131929E0C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8328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453CCCA-A335-4880-AFD1-F9C93915DF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C478A7C-72B0-43A8-A902-17793FCDE2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E88740-1F9E-4531-8FF1-B073F9D8D7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B9E44-29F0-40E7-8285-89257AB41C9A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2510BA7-AEF7-44A5-84BC-44E24C3C6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F42BD0-2EAD-472E-87AF-673829D76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66F8-1689-45AC-97FE-131929E0C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7891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B6DE9C-514B-480B-803F-C5E47960E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CFF0573-C785-4012-AD8D-E3A7A1D814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AF4F126-5121-47D3-A9B9-8BA635DE9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B9E44-29F0-40E7-8285-89257AB41C9A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6ED5ED1-9AEE-4E87-857E-3A2714D537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B075E9-DEBF-41BD-A14A-ED4CC2788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66F8-1689-45AC-97FE-131929E0C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7964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DBF9FB-0152-4B68-8EF3-CD856A2C1D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8EA0D68-B1BF-46E2-92D9-DCB9493CD0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088E79B-0F26-4F28-8476-0F2DD9164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B9E44-29F0-40E7-8285-89257AB41C9A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436F62-0663-42A8-BD8B-FA4101C31F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DFB91FF-1FAB-4FDF-97F2-E5E174C40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66F8-1689-45AC-97FE-131929E0C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1586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6C6B92-3D21-4156-835D-4A1FC6B2DB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0D4C645-2DE8-4748-8235-7409AD99B14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16163E0-F053-4386-9FD7-E88C34AFDE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15735A5-FA9B-4CB9-9F33-88CEABA69E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B9E44-29F0-40E7-8285-89257AB41C9A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51CB970-0B9F-43A2-B652-386ECBCD4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2598C12-201A-4BBF-8167-4622F9878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66F8-1689-45AC-97FE-131929E0C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4020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F7B8D2-E707-4D7C-ABCD-A41CBB9F21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307186-EDFF-45D9-B0AC-1346702263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A0BAAEE-62FD-4B77-8531-67E62812E3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E41F403-1275-43D9-B33E-DED77D6DEA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A917A15-23F8-44DA-92B9-9481114D6F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694CF79-2F1F-4539-BB51-F3CA1ADCED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B9E44-29F0-40E7-8285-89257AB41C9A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1E8EBC0-1834-4256-883E-7FED94BEEA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098E3F0-4A8A-4FE5-889A-A71B64D97B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66F8-1689-45AC-97FE-131929E0C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7923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5F774E-F1C1-4FC8-B453-EAD45802D1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45DAEF5-AA7F-450F-9A1F-711A4E163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B9E44-29F0-40E7-8285-89257AB41C9A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0A432FD-6A87-45C6-A8C2-5F4F806A30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F0F73B4-2072-4496-8957-CBF6759EF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66F8-1689-45AC-97FE-131929E0C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3992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3072DDC-C715-41A9-8030-90B38865E3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B9E44-29F0-40E7-8285-89257AB41C9A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9C725AF-10CE-4BDE-B981-89E9AD354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690F145-6AB1-4B12-B1AE-7330B4EC1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66F8-1689-45AC-97FE-131929E0C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3837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63C09E-72FE-45EB-B750-A0CAC756CF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102DA5E-42DF-4DFB-81B0-E550BB3F55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EF6A8D5-F47D-478C-834F-BC992188BC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33E8273-A260-416B-BD11-A8E2EB9C7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B9E44-29F0-40E7-8285-89257AB41C9A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8CD68A6-B312-4771-A28B-B21955879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4828AC9-A3E6-4CD9-845E-416558186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66F8-1689-45AC-97FE-131929E0C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6470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AD185B-288A-472D-9E6A-25F966D189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25E71A9-1C4A-4611-B027-CED83816D4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DD864AD-72AF-468F-8234-F3AD5D913C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7F4E066-D528-42F5-9C99-1568C66B81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B9E44-29F0-40E7-8285-89257AB41C9A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20E867A-1F82-4F6B-AF68-C87394BD1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55AC3B-87FA-4D45-A28F-476C595114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66F8-1689-45AC-97FE-131929E0C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0706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07A68A2-A71E-477C-AD26-D4DF0ADC26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F54CE5E-1045-4B1D-ADDE-D3F103F2CC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19886F8-5F46-4447-93E7-91631FA7A3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B9E44-29F0-40E7-8285-89257AB41C9A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F290DA5-4591-4B9E-B4B3-A0CBD9E5A8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F3748C-F31E-427A-ADB5-989AEBACFE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0266F8-1689-45AC-97FE-131929E0C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5653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4">
            <a:extLst>
              <a:ext uri="{FF2B5EF4-FFF2-40B4-BE49-F238E27FC236}">
                <a16:creationId xmlns:a16="http://schemas.microsoft.com/office/drawing/2014/main" id="{8AC9B682-6EBF-4DB6-99BA-285F23385EBE}"/>
              </a:ext>
            </a:extLst>
          </p:cNvPr>
          <p:cNvGraphicFramePr>
            <a:graphicFrameLocks noGrp="1"/>
          </p:cNvGraphicFramePr>
          <p:nvPr/>
        </p:nvGraphicFramePr>
        <p:xfrm>
          <a:off x="1202633" y="636684"/>
          <a:ext cx="8605375" cy="533378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61963">
                  <a:extLst>
                    <a:ext uri="{9D8B030D-6E8A-4147-A177-3AD203B41FA5}">
                      <a16:colId xmlns:a16="http://schemas.microsoft.com/office/drawing/2014/main" val="4189944786"/>
                    </a:ext>
                  </a:extLst>
                </a:gridCol>
                <a:gridCol w="3312786">
                  <a:extLst>
                    <a:ext uri="{9D8B030D-6E8A-4147-A177-3AD203B41FA5}">
                      <a16:colId xmlns:a16="http://schemas.microsoft.com/office/drawing/2014/main" val="2299774066"/>
                    </a:ext>
                  </a:extLst>
                </a:gridCol>
                <a:gridCol w="1530626">
                  <a:extLst>
                    <a:ext uri="{9D8B030D-6E8A-4147-A177-3AD203B41FA5}">
                      <a16:colId xmlns:a16="http://schemas.microsoft.com/office/drawing/2014/main" val="438078331"/>
                    </a:ext>
                  </a:extLst>
                </a:gridCol>
              </a:tblGrid>
              <a:tr h="380893">
                <a:tc>
                  <a:txBody>
                    <a:bodyPr/>
                    <a:lstStyle/>
                    <a:p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zard ratio (95% CI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75520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0(0.396-3.941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223646833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6(0.572-1.804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67263571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4(0.983-1.087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26351071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T duration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5(0.993-1.036</a:t>
                      </a:r>
                      <a:endParaRPr lang="zh-CN" altLang="en-US" sz="14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  <a:endParaRPr lang="zh-CN" altLang="en-US" sz="14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89308207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T-CL at presentation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(0.978-1.020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40847053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MAT per patient  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1(0.150-2.572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4097358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Pts with ≥ 2 MATs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54(0.341-7.095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17149196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Pts with left atrial MAT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1(.0162-1.610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6760860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cedural durat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(0.997-1.023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55264733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uoroscopic time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4(0.882-1.237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329446099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ute ablation result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3(0.991-4.579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31758161"/>
                  </a:ext>
                </a:extLst>
              </a:tr>
              <a:tr h="380893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7(0.986-1.134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309546034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VEDD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5(0.860-1.062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59870688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VEF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5(0.928-1.025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24562073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D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8(0.943-1.077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66928693"/>
                  </a:ext>
                </a:extLst>
              </a:tr>
              <a:tr h="2313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LD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7 (0.917-1.127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9719453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68FB7EA8-4BDA-4F59-9563-0DCD5ECBB24E}"/>
              </a:ext>
            </a:extLst>
          </p:cNvPr>
          <p:cNvSpPr txBox="1"/>
          <p:nvPr/>
        </p:nvSpPr>
        <p:spPr>
          <a:xfrm>
            <a:off x="1071638" y="6025136"/>
            <a:ext cx="88673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, macro-reentrant atrial tachycardia; AAD, anti-arrhythmic drug; LAD, left atrial diameter; LVEDD, left ventricular end diastolic diameter; LVESD, left ventricular end systolic diameter; RAD, right atrial diameter; RALD, right atrial longitude diameter; LVPW; Left ventricular posterior wall; LVEF, left ventricular ejection fraction;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trial tachyarrhythmia</a:t>
            </a:r>
            <a:endParaRPr lang="zh-CN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2DA0864-6809-4136-8DCF-F11D3CA852F6}"/>
              </a:ext>
            </a:extLst>
          </p:cNvPr>
          <p:cNvSpPr txBox="1"/>
          <p:nvPr/>
        </p:nvSpPr>
        <p:spPr>
          <a:xfrm>
            <a:off x="1867597" y="212686"/>
            <a:ext cx="727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</a:rPr>
              <a:t>U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nivariate Cox regression analysis for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Ta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ecurrence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07781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69</Words>
  <Application>Microsoft Office PowerPoint</Application>
  <PresentationFormat>宽屏</PresentationFormat>
  <Paragraphs>5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twwxh@126.com</dc:creator>
  <cp:lastModifiedBy>ttwwxh@126.com</cp:lastModifiedBy>
  <cp:revision>4</cp:revision>
  <dcterms:created xsi:type="dcterms:W3CDTF">2021-03-06T08:45:34Z</dcterms:created>
  <dcterms:modified xsi:type="dcterms:W3CDTF">2021-03-28T00:17:32Z</dcterms:modified>
</cp:coreProperties>
</file>